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91" r:id="rId2"/>
    <p:sldId id="263" r:id="rId3"/>
    <p:sldId id="274" r:id="rId4"/>
    <p:sldId id="293" r:id="rId5"/>
    <p:sldId id="292" r:id="rId6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osner" initials="r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8993" autoAdjust="0"/>
    <p:restoredTop sz="94660"/>
  </p:normalViewPr>
  <p:slideViewPr>
    <p:cSldViewPr snapToGrid="0">
      <p:cViewPr>
        <p:scale>
          <a:sx n="80" d="100"/>
          <a:sy n="80" d="100"/>
        </p:scale>
        <p:origin x="-870" y="22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6CF039-D32D-4152-B0BC-1FDE0EC1C85B}" type="datetimeFigureOut">
              <a:rPr lang="de-AT" smtClean="0"/>
              <a:pPr/>
              <a:t>16.04.2021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EB96D4-E282-4051-8C87-27B5EDBAA8B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="" xmlns:p14="http://schemas.microsoft.com/office/powerpoint/2010/main" val="3973644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EB96D4-E282-4051-8C87-27B5EDBAA8BD}" type="slidenum">
              <a:rPr lang="de-AT" smtClean="0"/>
              <a:pPr/>
              <a:t>2</a:t>
            </a:fld>
            <a:endParaRPr lang="de-AT"/>
          </a:p>
        </p:txBody>
      </p:sp>
    </p:spTree>
    <p:extLst>
      <p:ext uri="{BB962C8B-B14F-4D97-AF65-F5344CB8AC3E}">
        <p14:creationId xmlns="" xmlns:p14="http://schemas.microsoft.com/office/powerpoint/2010/main" val="783816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EB96D4-E282-4051-8C87-27B5EDBAA8BD}" type="slidenum">
              <a:rPr lang="de-AT" smtClean="0"/>
              <a:pPr/>
              <a:t>3</a:t>
            </a:fld>
            <a:endParaRPr lang="de-AT"/>
          </a:p>
        </p:txBody>
      </p:sp>
    </p:spTree>
    <p:extLst>
      <p:ext uri="{BB962C8B-B14F-4D97-AF65-F5344CB8AC3E}">
        <p14:creationId xmlns="" xmlns:p14="http://schemas.microsoft.com/office/powerpoint/2010/main" val="36574787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00182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58679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47734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52902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37627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02843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8424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16161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32645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37669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5179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1E8EE-2FC3-4A06-897B-3CBBDF849A0F}" type="datetimeFigureOut">
              <a:rPr lang="en-US" smtClean="0"/>
              <a:pPr/>
              <a:t>4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7BE6F-8480-4EB2-97B6-9901492EED4F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43040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078315" y="2696365"/>
            <a:ext cx="79325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 smtClean="0"/>
              <a:t>Electronic </a:t>
            </a:r>
            <a:r>
              <a:rPr lang="en-GB" sz="3600" b="1" dirty="0" smtClean="0"/>
              <a:t>supplementary material </a:t>
            </a:r>
            <a:r>
              <a:rPr lang="en-US" sz="3600" b="1" dirty="0" smtClean="0"/>
              <a:t>1-4 </a:t>
            </a:r>
            <a:endParaRPr lang="en-US" sz="36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054431" y="6041045"/>
            <a:ext cx="81108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1. Daily transpiration of  selected control trees (blue bars) and drought stressed (orange bars) European larch, hybrid larch and Japanese larch tree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164011" y="447472"/>
            <a:ext cx="3631975" cy="5667912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5294134" y="447471"/>
            <a:ext cx="17521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AT" dirty="0"/>
              <a:t>European </a:t>
            </a:r>
            <a:r>
              <a:rPr lang="de-AT" dirty="0" err="1"/>
              <a:t>larch</a:t>
            </a:r>
            <a:endParaRPr lang="de-AT" dirty="0"/>
          </a:p>
        </p:txBody>
      </p:sp>
      <p:sp>
        <p:nvSpPr>
          <p:cNvPr id="7" name="Textfeld 6"/>
          <p:cNvSpPr txBox="1"/>
          <p:nvPr/>
        </p:nvSpPr>
        <p:spPr>
          <a:xfrm>
            <a:off x="5405719" y="2204173"/>
            <a:ext cx="14612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AT" dirty="0"/>
              <a:t>Hybrid </a:t>
            </a:r>
            <a:r>
              <a:rPr lang="de-AT" dirty="0" err="1"/>
              <a:t>larch</a:t>
            </a:r>
            <a:endParaRPr lang="de-AT" dirty="0"/>
          </a:p>
        </p:txBody>
      </p:sp>
      <p:sp>
        <p:nvSpPr>
          <p:cNvPr id="8" name="Textfeld 7"/>
          <p:cNvSpPr txBox="1"/>
          <p:nvPr/>
        </p:nvSpPr>
        <p:spPr>
          <a:xfrm>
            <a:off x="5334000" y="3926732"/>
            <a:ext cx="183776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AT" dirty="0" err="1" smtClean="0"/>
              <a:t>Japanese</a:t>
            </a:r>
            <a:r>
              <a:rPr lang="de-AT" dirty="0" smtClean="0"/>
              <a:t> </a:t>
            </a:r>
            <a:r>
              <a:rPr lang="de-AT" dirty="0" err="1"/>
              <a:t>larch</a:t>
            </a:r>
            <a:endParaRPr lang="de-AT" dirty="0"/>
          </a:p>
        </p:txBody>
      </p:sp>
    </p:spTree>
    <p:extLst>
      <p:ext uri="{BB962C8B-B14F-4D97-AF65-F5344CB8AC3E}">
        <p14:creationId xmlns="" xmlns:p14="http://schemas.microsoft.com/office/powerpoint/2010/main" val="3463231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04952" y="5401278"/>
            <a:ext cx="100234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otographs of stem discs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drought stressed (S) trees of three different larch species;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 =European larch; HL= hybrid larch;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L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Japanese larch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US" sz="120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ence bars represent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m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395075" y="286053"/>
            <a:ext cx="8959999" cy="5040000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892186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04952" y="5401278"/>
            <a:ext cx="100234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3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dial lumen diameter and tangential double cell wall thickness of control trees (blue lines and symbols) and drought stressed trees (red lines and symbols). Each line represents one tree; trees are indicated by different symbols. The radial position is the distance in direction from pith to bark within the latest annual ring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 descr="supplement_Fig.5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92783" y="201880"/>
            <a:ext cx="9637512" cy="514481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11927" y="5401278"/>
            <a:ext cx="88708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line Resource 4. Relationships between the tangential lumen diameter and the initial biomass (a) and between the tangential conduit wall reinforcement (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²) and the initial biomass (b) of three different larch species; European larch (EL), hybrid larch (HL) and Japanese larch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de-AT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/>
          </a:p>
        </p:txBody>
      </p:sp>
      <p:pic>
        <p:nvPicPr>
          <p:cNvPr id="4" name="Grafik 3" descr="supplement_Fig.4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301577" y="142504"/>
            <a:ext cx="2703916" cy="520139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Benutzerdefiniert</PresentationFormat>
  <Paragraphs>13</Paragraphs>
  <Slides>5</Slides>
  <Notes>2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Office Theme</vt:lpstr>
      <vt:lpstr>Folie 1</vt:lpstr>
      <vt:lpstr>Folie 2</vt:lpstr>
      <vt:lpstr>Folie 3</vt:lpstr>
      <vt:lpstr>Folie 4</vt:lpstr>
      <vt:lpstr>Foli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ia</dc:creator>
  <cp:lastModifiedBy>Robert</cp:lastModifiedBy>
  <cp:revision>366</cp:revision>
  <cp:lastPrinted>2019-02-26T17:57:14Z</cp:lastPrinted>
  <dcterms:created xsi:type="dcterms:W3CDTF">2019-02-12T10:34:10Z</dcterms:created>
  <dcterms:modified xsi:type="dcterms:W3CDTF">2021-04-16T11:46:26Z</dcterms:modified>
</cp:coreProperties>
</file>